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70" d="100"/>
          <a:sy n="170" d="100"/>
        </p:scale>
        <p:origin x="1450" y="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'20200531-1'!$Q$38:$U$38</c:f>
                <c:numCache>
                  <c:formatCode>General</c:formatCode>
                  <c:ptCount val="5"/>
                  <c:pt idx="0">
                    <c:v>2.590259630838973E-2</c:v>
                  </c:pt>
                  <c:pt idx="1">
                    <c:v>1.6492378959272639E-2</c:v>
                  </c:pt>
                  <c:pt idx="2">
                    <c:v>2.3066475154757432E-2</c:v>
                  </c:pt>
                  <c:pt idx="3">
                    <c:v>1.9920910638649061E-2</c:v>
                  </c:pt>
                  <c:pt idx="4">
                    <c:v>2.8328811196502057E-2</c:v>
                  </c:pt>
                </c:numCache>
              </c:numRef>
            </c:plus>
            <c:minus>
              <c:numRef>
                <c:f>'20200531-1'!$Q$38:$U$38</c:f>
                <c:numCache>
                  <c:formatCode>General</c:formatCode>
                  <c:ptCount val="5"/>
                  <c:pt idx="0">
                    <c:v>2.590259630838973E-2</c:v>
                  </c:pt>
                  <c:pt idx="1">
                    <c:v>1.6492378959272639E-2</c:v>
                  </c:pt>
                  <c:pt idx="2">
                    <c:v>2.3066475154757432E-2</c:v>
                  </c:pt>
                  <c:pt idx="3">
                    <c:v>1.9920910638649061E-2</c:v>
                  </c:pt>
                  <c:pt idx="4">
                    <c:v>2.8328811196502057E-2</c:v>
                  </c:pt>
                </c:numCache>
              </c:numRef>
            </c:minus>
          </c:errBars>
          <c:cat>
            <c:strRef>
              <c:f>'20200531-1'!$Q$32:$U$32</c:f>
              <c:strCache>
                <c:ptCount val="5"/>
                <c:pt idx="0">
                  <c:v>z9</c:v>
                </c:pt>
                <c:pt idx="1">
                  <c:v>F</c:v>
                </c:pt>
                <c:pt idx="2">
                  <c:v>H</c:v>
                </c:pt>
                <c:pt idx="3">
                  <c:v>G</c:v>
                </c:pt>
                <c:pt idx="4">
                  <c:v>I</c:v>
                </c:pt>
              </c:strCache>
            </c:strRef>
          </c:cat>
          <c:val>
            <c:numRef>
              <c:f>'20200531-1'!$Q$37:$U$37</c:f>
              <c:numCache>
                <c:formatCode>General</c:formatCode>
                <c:ptCount val="5"/>
                <c:pt idx="0">
                  <c:v>0.42775013849999999</c:v>
                </c:pt>
                <c:pt idx="1">
                  <c:v>0.39508430900000002</c:v>
                </c:pt>
                <c:pt idx="2">
                  <c:v>0.41323994600000002</c:v>
                </c:pt>
                <c:pt idx="3">
                  <c:v>0.40200199400000003</c:v>
                </c:pt>
                <c:pt idx="4">
                  <c:v>0.4020644945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F0-43EB-B84B-9B1F13A39A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5692928"/>
        <c:axId val="165694464"/>
      </c:barChart>
      <c:catAx>
        <c:axId val="1656929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5694464"/>
        <c:crosses val="autoZero"/>
        <c:auto val="1"/>
        <c:lblAlgn val="ctr"/>
        <c:lblOffset val="100"/>
        <c:noMultiLvlLbl val="0"/>
      </c:catAx>
      <c:valAx>
        <c:axId val="165694464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5692928"/>
        <c:crosses val="autoZero"/>
        <c:crossBetween val="between"/>
        <c:majorUnit val="0.1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'20200531-1'!$P$55:$U$55</c:f>
                <c:numCache>
                  <c:formatCode>General</c:formatCode>
                  <c:ptCount val="6"/>
                  <c:pt idx="0">
                    <c:v>1.1856217124575978E-2</c:v>
                  </c:pt>
                  <c:pt idx="1">
                    <c:v>3.1417598542306913E-2</c:v>
                  </c:pt>
                  <c:pt idx="2">
                    <c:v>8.6567156097698481E-3</c:v>
                  </c:pt>
                  <c:pt idx="3">
                    <c:v>7.841898063060751E-3</c:v>
                  </c:pt>
                  <c:pt idx="4">
                    <c:v>3.6430447187451747E-3</c:v>
                  </c:pt>
                  <c:pt idx="5">
                    <c:v>1.442012676319024E-2</c:v>
                  </c:pt>
                </c:numCache>
              </c:numRef>
            </c:plus>
            <c:minus>
              <c:numRef>
                <c:f>'20200531-1'!$P$55:$U$55</c:f>
                <c:numCache>
                  <c:formatCode>General</c:formatCode>
                  <c:ptCount val="6"/>
                  <c:pt idx="0">
                    <c:v>1.1856217124575978E-2</c:v>
                  </c:pt>
                  <c:pt idx="1">
                    <c:v>3.1417598542306913E-2</c:v>
                  </c:pt>
                  <c:pt idx="2">
                    <c:v>8.6567156097698481E-3</c:v>
                  </c:pt>
                  <c:pt idx="3">
                    <c:v>7.841898063060751E-3</c:v>
                  </c:pt>
                  <c:pt idx="4">
                    <c:v>3.6430447187451747E-3</c:v>
                  </c:pt>
                  <c:pt idx="5">
                    <c:v>1.442012676319024E-2</c:v>
                  </c:pt>
                </c:numCache>
              </c:numRef>
            </c:minus>
          </c:errBars>
          <c:cat>
            <c:strRef>
              <c:f>'20200531-1'!$P$53:$U$53</c:f>
              <c:strCache>
                <c:ptCount val="6"/>
                <c:pt idx="0">
                  <c:v>z9</c:v>
                </c:pt>
                <c:pt idx="1">
                  <c:v>d</c:v>
                </c:pt>
                <c:pt idx="2">
                  <c:v>e</c:v>
                </c:pt>
                <c:pt idx="3">
                  <c:v>b</c:v>
                </c:pt>
                <c:pt idx="4">
                  <c:v>c</c:v>
                </c:pt>
                <c:pt idx="5">
                  <c:v>a</c:v>
                </c:pt>
              </c:strCache>
            </c:strRef>
          </c:cat>
          <c:val>
            <c:numRef>
              <c:f>'20200531-1'!$P$54:$U$54</c:f>
              <c:numCache>
                <c:formatCode>General</c:formatCode>
                <c:ptCount val="6"/>
                <c:pt idx="0">
                  <c:v>0.4605479973984275</c:v>
                </c:pt>
                <c:pt idx="1">
                  <c:v>0.33730041699060204</c:v>
                </c:pt>
                <c:pt idx="2">
                  <c:v>0.3695873070970892</c:v>
                </c:pt>
                <c:pt idx="3">
                  <c:v>0.2479306910797546</c:v>
                </c:pt>
                <c:pt idx="4">
                  <c:v>0.26116880678207699</c:v>
                </c:pt>
                <c:pt idx="5">
                  <c:v>0.21004285152296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C2-4354-B987-FE793B3D75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5760000"/>
        <c:axId val="165761792"/>
      </c:barChart>
      <c:catAx>
        <c:axId val="165760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5761792"/>
        <c:crosses val="autoZero"/>
        <c:auto val="1"/>
        <c:lblAlgn val="ctr"/>
        <c:lblOffset val="100"/>
        <c:noMultiLvlLbl val="0"/>
      </c:catAx>
      <c:valAx>
        <c:axId val="165761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5760000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170832" y="450364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193238" y="450364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396589" y="508901"/>
            <a:ext cx="2685818" cy="2568784"/>
            <a:chOff x="311134" y="508901"/>
            <a:chExt cx="2685818" cy="2568784"/>
          </a:xfrm>
        </p:grpSpPr>
        <p:graphicFrame>
          <p:nvGraphicFramePr>
            <p:cNvPr id="2" name="图表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31353057"/>
                </p:ext>
              </p:extLst>
            </p:nvPr>
          </p:nvGraphicFramePr>
          <p:xfrm>
            <a:off x="836952" y="698076"/>
            <a:ext cx="216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600737" y="152127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2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00737" y="2060895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00737" y="179108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1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00737" y="125146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3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00737" y="98165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4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0737" y="71184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5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43451" y="768993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422541" y="89085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801631" y="81770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173106" y="86114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550286" y="84209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8908584">
              <a:off x="706636" y="2231932"/>
              <a:ext cx="66556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 err="1" smtClean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endParaRPr lang="en-US" altLang="zh-CN" sz="900" i="1" dirty="0" smtClean="0">
                <a:latin typeface="Arial" panose="020B0604020202020204" pitchFamily="34" charset="0"/>
                <a:ea typeface="Arial Unicode MS"/>
                <a:cs typeface="Arial" panose="020B0604020202020204" pitchFamily="34" charset="0"/>
              </a:endParaRPr>
            </a:p>
            <a:p>
              <a:r>
                <a:rPr lang="en-US" altLang="zh-CN" sz="900" i="1" dirty="0" smtClean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8908584">
              <a:off x="1149403" y="2227926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19" name="矩形 18"/>
            <p:cNvSpPr/>
            <p:nvPr/>
          </p:nvSpPr>
          <p:spPr>
            <a:xfrm rot="18908584">
              <a:off x="1907580" y="2237196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20" name="矩形 19"/>
            <p:cNvSpPr/>
            <p:nvPr/>
          </p:nvSpPr>
          <p:spPr>
            <a:xfrm rot="18908584">
              <a:off x="1534769" y="2232867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21" name="矩形 20"/>
            <p:cNvSpPr/>
            <p:nvPr/>
          </p:nvSpPr>
          <p:spPr>
            <a:xfrm rot="18908584">
              <a:off x="2297464" y="2232867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 flipV="1">
              <a:off x="311134" y="508901"/>
              <a:ext cx="492443" cy="256878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FP intensity ratio </a:t>
              </a:r>
            </a:p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iquid medium 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mycelial protein extract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3364615" y="508901"/>
            <a:ext cx="3187623" cy="2568784"/>
            <a:chOff x="3193705" y="508901"/>
            <a:chExt cx="3187623" cy="2568784"/>
          </a:xfrm>
        </p:grpSpPr>
        <p:graphicFrame>
          <p:nvGraphicFramePr>
            <p:cNvPr id="26" name="图表 2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38440354"/>
                </p:ext>
              </p:extLst>
            </p:nvPr>
          </p:nvGraphicFramePr>
          <p:xfrm>
            <a:off x="3681328" y="690586"/>
            <a:ext cx="270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8" name="TextBox 27"/>
            <p:cNvSpPr txBox="1"/>
            <p:nvPr/>
          </p:nvSpPr>
          <p:spPr>
            <a:xfrm>
              <a:off x="3484083" y="152348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2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484083" y="2063105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484083" y="179329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1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484083" y="125367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3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484083" y="98386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4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484083" y="71405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.5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906877" y="70511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316452" y="99086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716502" y="97181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520984" y="1277151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113501" y="1302683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918909" y="1392567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矩形 47"/>
            <p:cNvSpPr/>
            <p:nvPr/>
          </p:nvSpPr>
          <p:spPr>
            <a:xfrm rot="18908584">
              <a:off x="3556957" y="2236278"/>
              <a:ext cx="665567" cy="369332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900" i="1" dirty="0" err="1" smtClean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endParaRPr lang="en-US" altLang="zh-CN" sz="900" i="1" dirty="0" smtClean="0">
                <a:latin typeface="Arial" panose="020B0604020202020204" pitchFamily="34" charset="0"/>
                <a:ea typeface="Arial Unicode MS"/>
                <a:cs typeface="Arial" panose="020B0604020202020204" pitchFamily="34" charset="0"/>
              </a:endParaRPr>
            </a:p>
            <a:p>
              <a:pPr algn="r"/>
              <a:r>
                <a:rPr lang="en-US" altLang="zh-CN" sz="900" i="1" dirty="0" smtClean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50" name="矩形 49"/>
            <p:cNvSpPr/>
            <p:nvPr/>
          </p:nvSpPr>
          <p:spPr>
            <a:xfrm rot="18908584">
              <a:off x="5365495" y="2365994"/>
              <a:ext cx="979755" cy="369332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33G/N173G</a:t>
              </a:r>
            </a:p>
            <a:p>
              <a:pPr algn="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N315G/N381G</a:t>
              </a:r>
              <a:endPara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矩形 50"/>
            <p:cNvSpPr/>
            <p:nvPr/>
          </p:nvSpPr>
          <p:spPr>
            <a:xfrm rot="18908584">
              <a:off x="4182061" y="2515051"/>
              <a:ext cx="1345240" cy="230832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33G/N315G/N381G</a:t>
              </a:r>
              <a:endPara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矩形 51"/>
            <p:cNvSpPr/>
            <p:nvPr/>
          </p:nvSpPr>
          <p:spPr>
            <a:xfrm rot="18908584">
              <a:off x="4578870" y="2515051"/>
              <a:ext cx="1345240" cy="230832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73G/N315G/N381G</a:t>
              </a:r>
              <a:endPara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矩形 52"/>
            <p:cNvSpPr/>
            <p:nvPr/>
          </p:nvSpPr>
          <p:spPr>
            <a:xfrm rot="18908584">
              <a:off x="3717113" y="2374849"/>
              <a:ext cx="947695" cy="230832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33G/N173G</a:t>
              </a:r>
              <a:endPara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矩形 53"/>
            <p:cNvSpPr/>
            <p:nvPr/>
          </p:nvSpPr>
          <p:spPr>
            <a:xfrm rot="18908584">
              <a:off x="4107842" y="2374849"/>
              <a:ext cx="947695" cy="230832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315G/N381G</a:t>
              </a:r>
              <a:endPara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 flipV="1">
              <a:off x="3193705" y="508901"/>
              <a:ext cx="492443" cy="256878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FP intensity ratio </a:t>
              </a:r>
            </a:p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iquid medium 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mycelial protein extract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17243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A4 纸张(210x297 毫米)</PresentationFormat>
  <Paragraphs>4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 Unicode MS</vt:lpstr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宁</dc:creator>
  <cp:lastModifiedBy>焦玉霞</cp:lastModifiedBy>
  <cp:revision>5</cp:revision>
  <dcterms:created xsi:type="dcterms:W3CDTF">2021-07-07T14:30:05Z</dcterms:created>
  <dcterms:modified xsi:type="dcterms:W3CDTF">2021-07-08T11:40:41Z</dcterms:modified>
</cp:coreProperties>
</file>